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5" d="100"/>
          <a:sy n="85" d="100"/>
        </p:scale>
        <p:origin x="-1208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x-none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CAD5B-A29D-204C-BF51-FF00B069EECB}" type="datetimeFigureOut">
              <a:rPr lang="en-US" smtClean="0"/>
              <a:t>28/0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AB16C9-C085-1843-8F5F-B1A75A8CF3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71575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CAD5B-A29D-204C-BF51-FF00B069EECB}" type="datetimeFigureOut">
              <a:rPr lang="en-US" smtClean="0"/>
              <a:t>28/0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AB16C9-C085-1843-8F5F-B1A75A8CF3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91605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CAD5B-A29D-204C-BF51-FF00B069EECB}" type="datetimeFigureOut">
              <a:rPr lang="en-US" smtClean="0"/>
              <a:t>28/0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AB16C9-C085-1843-8F5F-B1A75A8CF3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67105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CAD5B-A29D-204C-BF51-FF00B069EECB}" type="datetimeFigureOut">
              <a:rPr lang="en-US" smtClean="0"/>
              <a:t>28/0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AB16C9-C085-1843-8F5F-B1A75A8CF3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79283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CAD5B-A29D-204C-BF51-FF00B069EECB}" type="datetimeFigureOut">
              <a:rPr lang="en-US" smtClean="0"/>
              <a:t>28/0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AB16C9-C085-1843-8F5F-B1A75A8CF3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62315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CAD5B-A29D-204C-BF51-FF00B069EECB}" type="datetimeFigureOut">
              <a:rPr lang="en-US" smtClean="0"/>
              <a:t>28/05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AB16C9-C085-1843-8F5F-B1A75A8CF3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97633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CAD5B-A29D-204C-BF51-FF00B069EECB}" type="datetimeFigureOut">
              <a:rPr lang="en-US" smtClean="0"/>
              <a:t>28/05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AB16C9-C085-1843-8F5F-B1A75A8CF3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46314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CAD5B-A29D-204C-BF51-FF00B069EECB}" type="datetimeFigureOut">
              <a:rPr lang="en-US" smtClean="0"/>
              <a:t>28/05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AB16C9-C085-1843-8F5F-B1A75A8CF3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50362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CAD5B-A29D-204C-BF51-FF00B069EECB}" type="datetimeFigureOut">
              <a:rPr lang="en-US" smtClean="0"/>
              <a:t>28/05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AB16C9-C085-1843-8F5F-B1A75A8CF3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16907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CAD5B-A29D-204C-BF51-FF00B069EECB}" type="datetimeFigureOut">
              <a:rPr lang="en-US" smtClean="0"/>
              <a:t>28/05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AB16C9-C085-1843-8F5F-B1A75A8CF3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58734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CAD5B-A29D-204C-BF51-FF00B069EECB}" type="datetimeFigureOut">
              <a:rPr lang="en-US" smtClean="0"/>
              <a:t>28/05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AB16C9-C085-1843-8F5F-B1A75A8CF3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67869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7CAD5B-A29D-204C-BF51-FF00B069EECB}" type="datetimeFigureOut">
              <a:rPr lang="en-US" smtClean="0"/>
              <a:t>28/0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AB16C9-C085-1843-8F5F-B1A75A8CF3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50477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6927" y="939799"/>
            <a:ext cx="8535448" cy="2840319"/>
          </a:xfrm>
          <a:prstGeom prst="rect">
            <a:avLst/>
          </a:prstGeom>
        </p:spPr>
      </p:pic>
      <p:cxnSp>
        <p:nvCxnSpPr>
          <p:cNvPr id="6" name="Straight Connector 5"/>
          <p:cNvCxnSpPr/>
          <p:nvPr/>
        </p:nvCxnSpPr>
        <p:spPr>
          <a:xfrm flipH="1">
            <a:off x="5752353" y="1269998"/>
            <a:ext cx="171823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 flipH="1">
            <a:off x="5558118" y="1011525"/>
            <a:ext cx="1673411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5752353" y="1269998"/>
            <a:ext cx="0" cy="28388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5561106" y="1011525"/>
            <a:ext cx="0" cy="28388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 flipH="1">
            <a:off x="4586941" y="776948"/>
            <a:ext cx="1718235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4592918" y="794879"/>
            <a:ext cx="0" cy="28388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6499412" y="1016001"/>
            <a:ext cx="299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20" name="TextBox 19"/>
          <p:cNvSpPr txBox="1"/>
          <p:nvPr/>
        </p:nvSpPr>
        <p:spPr>
          <a:xfrm>
            <a:off x="6173700" y="750053"/>
            <a:ext cx="299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21" name="TextBox 20"/>
          <p:cNvSpPr txBox="1"/>
          <p:nvPr/>
        </p:nvSpPr>
        <p:spPr>
          <a:xfrm>
            <a:off x="5325053" y="499046"/>
            <a:ext cx="299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23" name="Rectangle 22"/>
          <p:cNvSpPr/>
          <p:nvPr/>
        </p:nvSpPr>
        <p:spPr>
          <a:xfrm>
            <a:off x="448263" y="4258519"/>
            <a:ext cx="8319191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dirty="0" smtClean="0"/>
              <a:t>Supplementary Figure 1 – Increased expression of CD163, PPAR- </a:t>
            </a:r>
            <a:r>
              <a:rPr lang="en-US" sz="1400" dirty="0" err="1" smtClean="0"/>
              <a:t>ϒ</a:t>
            </a:r>
            <a:r>
              <a:rPr lang="en-US" sz="1400" dirty="0" smtClean="0"/>
              <a:t> and MRS1/SRA-1 in skin cells from RR/HIV group.  </a:t>
            </a:r>
            <a:r>
              <a:rPr lang="en-US" sz="1400" dirty="0" smtClean="0"/>
              <a:t>The quantification analysis was performed using </a:t>
            </a:r>
            <a:r>
              <a:rPr lang="en-US" sz="1400" dirty="0" err="1" smtClean="0"/>
              <a:t>ImageJ</a:t>
            </a:r>
            <a:r>
              <a:rPr lang="en-US" sz="1400" dirty="0" smtClean="0"/>
              <a:t> Software 1.52 version (NIH, Bethesda, Maryland). The image was inserted into the software and the IHC profiler plugin was used, where only the markings were selected corresponding to the DAB. A threshold was performed after converting the image to RGB-stack to measure the percentage of the positive area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40777282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95</Words>
  <Application>Microsoft Macintosh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Fiocruz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berta Olmo</dc:creator>
  <cp:lastModifiedBy>Roberta Olmo</cp:lastModifiedBy>
  <cp:revision>3</cp:revision>
  <dcterms:created xsi:type="dcterms:W3CDTF">2020-05-28T20:37:25Z</dcterms:created>
  <dcterms:modified xsi:type="dcterms:W3CDTF">2020-05-28T20:52:35Z</dcterms:modified>
</cp:coreProperties>
</file>